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9" d="100"/>
          <a:sy n="89" d="100"/>
        </p:scale>
        <p:origin x="-706" y="362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609600" y="609600"/>
          <a:ext cx="5796000" cy="7011380"/>
        </p:xfrm>
        <a:graphic>
          <a:graphicData uri="http://schemas.openxmlformats.org/drawingml/2006/table">
            <a:tbl>
              <a:tblPr/>
              <a:tblGrid>
                <a:gridCol w="1404000"/>
                <a:gridCol w="360000"/>
                <a:gridCol w="360000"/>
                <a:gridCol w="360000"/>
                <a:gridCol w="2268000"/>
                <a:gridCol w="360000"/>
                <a:gridCol w="324000"/>
                <a:gridCol w="360000"/>
              </a:tblGrid>
              <a:tr h="182432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enus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R1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R3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B2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enus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R1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R3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B2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rvibacul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8447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7296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Kaisti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FC0C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194675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eto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A9B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enotrophomona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D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9709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B78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phingob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1386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B8C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23B6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elotomacul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B477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FC0C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A5BB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opioni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72A6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497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isseri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9457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4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hauer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BAC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5276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DA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uteimona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7E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B487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8EAA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loramato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B306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echloromona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4C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A477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E9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gnetospirill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A467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33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usi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D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8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A77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ulfuricurv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23A6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6407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ldicopro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D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E9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poranaero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E7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7427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CP-6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E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E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E79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leomorphomona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0759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C326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hermodesulfob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D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hermu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8447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608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6407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reptococcus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B477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eromicrob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0386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B7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esulfotomaculum_Desulfovirgul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497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FC0C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E9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evotell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2698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F366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odesto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D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E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D78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lavo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8447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FC0C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8437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thylo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1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4A77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revi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E356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DA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rco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D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D79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etzi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A7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0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43D7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dimini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B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47899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hermoanaero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33C6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3C3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itrospir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4A7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9EE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edomicrob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9457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E809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9457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radyrhizob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86A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B78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phingomona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D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E7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thanosaet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527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oorell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7427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688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ovispirill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86A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B78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ryne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8437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98B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A7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etro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1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A7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4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esulfosporosinu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33B6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8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Oscillospir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B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C8D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CBD8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seudonocardi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A7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88A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9447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prococcu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ADC1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loaci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A467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B487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ethiosulfati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D4B7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4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dimenti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7427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8E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A73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588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98B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A7093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elmatospirill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A648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407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oseococcu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AFC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Zoogloe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8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53F7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8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mycolatopsi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CCD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E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6188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yntrophomona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B487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497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BC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esulfotomacul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BCCC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tinomyce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D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688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A467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aecali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D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96B0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ndidatus</a:t>
                      </a:r>
                      <a:r>
                        <a:rPr lang="en-IN" sz="1200" b="1" i="1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oli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497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D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acillus</a:t>
                      </a: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0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8FA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evosi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E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A8B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9457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esulfurispor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C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8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8FA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thylosinu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4A7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FC0C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C497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iothermu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4C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D79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thano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9457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E7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fidobacter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D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8EAA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epidimicrob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A467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E7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ndidatus</a:t>
                      </a:r>
                      <a:r>
                        <a:rPr lang="en-IN" sz="1200" b="1" i="1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Koribacter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D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E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DA5BB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eillonell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8437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hermovenabul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7B9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E7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8FA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idiphilium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A477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4D7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einococcu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1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E4D78"/>
                    </a:solidFill>
                  </a:tcPr>
                </a:tc>
              </a:tr>
              <a:tr h="1440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opionicimonas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B487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8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E4D7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i="1" u="none" strike="noStrike" dirty="0" err="1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arciella</a:t>
                      </a:r>
                      <a:endParaRPr lang="en-IN" sz="1200" b="1" i="1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C98B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D8E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630" marR="1630" marT="16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F4E79"/>
                    </a:solidFill>
                  </a:tcPr>
                </a:tc>
              </a:tr>
            </a:tbl>
          </a:graphicData>
        </a:graphic>
      </p:graphicFrame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/>
          <a:srcRect l="33088" t="55808" r="31228" b="40727"/>
          <a:stretch>
            <a:fillRect/>
          </a:stretch>
        </p:blipFill>
        <p:spPr bwMode="auto">
          <a:xfrm>
            <a:off x="686599" y="7877175"/>
            <a:ext cx="5580000" cy="3047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TextBox 4"/>
          <p:cNvSpPr txBox="1">
            <a:spLocks noChangeArrowheads="1"/>
          </p:cNvSpPr>
          <p:nvPr/>
        </p:nvSpPr>
        <p:spPr bwMode="auto">
          <a:xfrm>
            <a:off x="534199" y="8258175"/>
            <a:ext cx="26193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0</a:t>
            </a:r>
            <a:endParaRPr lang="en-IN" sz="1200" b="1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5"/>
          <p:cNvSpPr txBox="1">
            <a:spLocks noChangeArrowheads="1"/>
          </p:cNvSpPr>
          <p:nvPr/>
        </p:nvSpPr>
        <p:spPr bwMode="auto">
          <a:xfrm>
            <a:off x="5947574" y="8258175"/>
            <a:ext cx="37702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0.1</a:t>
            </a:r>
            <a:endParaRPr lang="en-IN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6"/>
          <p:cNvSpPr txBox="1">
            <a:spLocks noChangeArrowheads="1"/>
          </p:cNvSpPr>
          <p:nvPr/>
        </p:nvSpPr>
        <p:spPr bwMode="auto">
          <a:xfrm>
            <a:off x="2799561" y="8334375"/>
            <a:ext cx="146867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Percent Abundance</a:t>
            </a:r>
            <a:endParaRPr lang="en-IN" sz="1200" b="1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88</Words>
  <Application>Microsoft Office PowerPoint</Application>
  <PresentationFormat>A4 Paper (210x297 mm)</PresentationFormat>
  <Paragraphs>8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joy</dc:creator>
  <cp:lastModifiedBy>User</cp:lastModifiedBy>
  <cp:revision>4</cp:revision>
  <dcterms:created xsi:type="dcterms:W3CDTF">2006-08-16T00:00:00Z</dcterms:created>
  <dcterms:modified xsi:type="dcterms:W3CDTF">2018-09-08T07:50:39Z</dcterms:modified>
</cp:coreProperties>
</file>